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37" r:id="rId2"/>
    <p:sldId id="438" r:id="rId3"/>
    <p:sldId id="436" r:id="rId4"/>
    <p:sldId id="439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94" d="100"/>
          <a:sy n="94" d="100"/>
        </p:scale>
        <p:origin x="106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69A8D62-279A-4C34-825F-043F9351B89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4633421-9E97-4DC0-BF5A-9A4C316B23D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D8F0066-C446-4F18-B055-AB3DF93416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33326-799B-457F-914B-198F85255C73}" type="datetimeFigureOut">
              <a:rPr kumimoji="1" lang="ja-JP" altLang="en-US" smtClean="0"/>
              <a:t>2022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72DE9B2-F9EA-43E4-A047-35AB4296FB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0AB825A-1F8A-4D4A-A869-AA01F15167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E6BD-FE60-4A1F-861F-BE2EC9D42A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96661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599F1E5-4FDB-4523-9948-DC95493848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B129486-A0E7-4DE5-9D9C-BC4F6D6D7A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B886867-B5A8-4C98-BFAA-88BFB72DF7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33326-799B-457F-914B-198F85255C73}" type="datetimeFigureOut">
              <a:rPr kumimoji="1" lang="ja-JP" altLang="en-US" smtClean="0"/>
              <a:t>2022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F4F2AB7-6B4B-49AB-8079-B90600DB21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AC54573-5201-4B8F-9C6A-021AB46098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E6BD-FE60-4A1F-861F-BE2EC9D42A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7967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93AB0FB-7B4F-457C-85BB-1D19F11B5B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E1CE96A-F9B6-4C6A-9801-0478FDF242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5ECC1E2-E57A-43B4-B68C-CFFA84E9A8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33326-799B-457F-914B-198F85255C73}" type="datetimeFigureOut">
              <a:rPr kumimoji="1" lang="ja-JP" altLang="en-US" smtClean="0"/>
              <a:t>2022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0BB5A5B-78E1-4495-A82A-B985AC7B6C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A433875-B2FB-4739-8CFF-74BB9A6D39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E6BD-FE60-4A1F-861F-BE2EC9D42A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0234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6257585-3730-483B-A77F-35CA70C9E9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C0512C3-6EA8-46DF-A616-EB4DE2F49C0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EAFBA83-238F-4142-AB38-E63AD43095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33326-799B-457F-914B-198F85255C73}" type="datetimeFigureOut">
              <a:rPr kumimoji="1" lang="ja-JP" altLang="en-US" smtClean="0"/>
              <a:t>2022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A71FBF6-7179-468B-8846-15B8AD42CB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B4D99B4-76BB-4D2D-BBC3-E6692390C4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E6BD-FE60-4A1F-861F-BE2EC9D42A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6990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4C5C3C1-FF64-4E5F-A7FA-7A48738D70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F2159EC-D1B5-4DD4-A261-5833A6C7CD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238615A-6E72-4B00-810C-AE2C813CF7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33326-799B-457F-914B-198F85255C73}" type="datetimeFigureOut">
              <a:rPr kumimoji="1" lang="ja-JP" altLang="en-US" smtClean="0"/>
              <a:t>2022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7441394-3C99-4E4C-B438-3E01568CD7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7DA59AE-15D3-4E99-A626-5D644C75DC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E6BD-FE60-4A1F-861F-BE2EC9D42A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21808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BC2C872-FF3C-4E9E-B954-FBABFBAA7E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0974F07-AD46-40E1-98A7-6E08B24981F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606E77D-9EC4-46DF-A4BB-7430C21577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ADC896B-C3AF-45BA-A312-7BDF680597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33326-799B-457F-914B-198F85255C73}" type="datetimeFigureOut">
              <a:rPr kumimoji="1" lang="ja-JP" altLang="en-US" smtClean="0"/>
              <a:t>2022/2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A604282-60B2-458D-B953-410BEC22E7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5588450-C20C-4D4A-9F6D-FE71D1B74B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E6BD-FE60-4A1F-861F-BE2EC9D42A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7056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6DC8B1A-80E8-45C5-B0A0-85C700E4D0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2393F0C-41B5-4101-B3B4-24A8ABB6A5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824DA23-FBD6-4369-AAD9-C1BEDAE740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A748CB3-9670-44F3-9DF3-4701EF291D2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4AC567B-FA9F-493D-9488-C1807595C4C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437B72B-ECC8-4B20-982E-05017BB893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33326-799B-457F-914B-198F85255C73}" type="datetimeFigureOut">
              <a:rPr kumimoji="1" lang="ja-JP" altLang="en-US" smtClean="0"/>
              <a:t>2022/2/1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B9C01E3-2B01-4429-8FCF-61DB470425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42345DA-EBDF-4DCF-BAE0-8E467072A0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E6BD-FE60-4A1F-861F-BE2EC9D42A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14433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C40BDD8-CC6D-4616-A11D-E585542959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403509D-1E51-4CFA-97AF-36572100CC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33326-799B-457F-914B-198F85255C73}" type="datetimeFigureOut">
              <a:rPr kumimoji="1" lang="ja-JP" altLang="en-US" smtClean="0"/>
              <a:t>2022/2/1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1DFA2BA-455E-45C9-B3CE-5FD5FA9956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AE250CD-2F4E-4127-BA31-93CF44591E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E6BD-FE60-4A1F-861F-BE2EC9D42A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09893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79C6253-B3A7-47FD-910C-FB38D81DEA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33326-799B-457F-914B-198F85255C73}" type="datetimeFigureOut">
              <a:rPr kumimoji="1" lang="ja-JP" altLang="en-US" smtClean="0"/>
              <a:t>2022/2/1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A976947-E2DE-464F-B99C-0B32696B71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65503D1-843B-4673-9395-B358DA9082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E6BD-FE60-4A1F-861F-BE2EC9D42A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55162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2A4C1A3-8BD2-4C91-9831-C38BF45283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76AB3D7-E4B6-4968-AADE-D98951DE29D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616BFD8-7A84-4167-A905-FC5154AE5E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07E1C42-5214-4EBE-B714-1267E9683E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33326-799B-457F-914B-198F85255C73}" type="datetimeFigureOut">
              <a:rPr kumimoji="1" lang="ja-JP" altLang="en-US" smtClean="0"/>
              <a:t>2022/2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7E82469-D72B-4CBB-AAD8-AE9DE4861E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AB091D0-9BBD-49AE-80A7-AF41513BF2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E6BD-FE60-4A1F-861F-BE2EC9D42A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20524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FD64E0-F27E-4333-9DA9-B2F9E17734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311291B0-2ED1-412E-90AD-20235877663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5086855-4370-4A04-90C0-FCCE9DC321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3B46965-0FD8-4E97-AE27-772E11F429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33326-799B-457F-914B-198F85255C73}" type="datetimeFigureOut">
              <a:rPr kumimoji="1" lang="ja-JP" altLang="en-US" smtClean="0"/>
              <a:t>2022/2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DAB02D6-277D-4125-8D56-00A2EC8032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829018D-64D6-46BD-B51C-D57657AFA3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E6BD-FE60-4A1F-861F-BE2EC9D42A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98825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679F16F-A5A0-4957-818D-C688E5BA0C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09B8C5F-E422-4D55-931C-E369CAB74E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E39DD26-F5C5-45E9-9837-3D8A1C39C48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933326-799B-457F-914B-198F85255C73}" type="datetimeFigureOut">
              <a:rPr kumimoji="1" lang="ja-JP" altLang="en-US" smtClean="0"/>
              <a:t>2022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35AC1C6-9800-4AD7-BA65-066F7167FC9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F3CECA3-82FD-4C17-B3EE-FFCA6600E82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30E6BD-FE60-4A1F-861F-BE2EC9D42A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75177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hyperlink" Target="http://www.processmacro.org/" TargetMode="Externa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37468B3F-DE52-4230-BE93-D0512E2F88A4}"/>
              </a:ext>
            </a:extLst>
          </p:cNvPr>
          <p:cNvGrpSpPr/>
          <p:nvPr/>
        </p:nvGrpSpPr>
        <p:grpSpPr>
          <a:xfrm>
            <a:off x="898036" y="802632"/>
            <a:ext cx="10744235" cy="5126000"/>
            <a:chOff x="1019075" y="916932"/>
            <a:chExt cx="10744235" cy="5126000"/>
          </a:xfrm>
        </p:grpSpPr>
        <p:grpSp>
          <p:nvGrpSpPr>
            <p:cNvPr id="8" name="グループ化 7">
              <a:extLst>
                <a:ext uri="{FF2B5EF4-FFF2-40B4-BE49-F238E27FC236}">
                  <a16:creationId xmlns:a16="http://schemas.microsoft.com/office/drawing/2014/main" id="{B8A01631-F7D8-474E-9F8A-2A6066D47A60}"/>
                </a:ext>
              </a:extLst>
            </p:cNvPr>
            <p:cNvGrpSpPr/>
            <p:nvPr/>
          </p:nvGrpSpPr>
          <p:grpSpPr>
            <a:xfrm>
              <a:off x="1022424" y="916932"/>
              <a:ext cx="5073576" cy="4205830"/>
              <a:chOff x="875048" y="1037512"/>
              <a:chExt cx="3875750" cy="3212871"/>
            </a:xfrm>
          </p:grpSpPr>
          <p:pic>
            <p:nvPicPr>
              <p:cNvPr id="4" name="図 3">
                <a:extLst>
                  <a:ext uri="{FF2B5EF4-FFF2-40B4-BE49-F238E27FC236}">
                    <a16:creationId xmlns:a16="http://schemas.microsoft.com/office/drawing/2014/main" id="{7C524B5E-FA59-454A-8C01-23D82B73F4F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958757" y="1037512"/>
                <a:ext cx="3792041" cy="2627604"/>
              </a:xfrm>
              <a:prstGeom prst="rect">
                <a:avLst/>
              </a:prstGeom>
            </p:spPr>
          </p:pic>
          <p:pic>
            <p:nvPicPr>
              <p:cNvPr id="6" name="図 5">
                <a:extLst>
                  <a:ext uri="{FF2B5EF4-FFF2-40B4-BE49-F238E27FC236}">
                    <a16:creationId xmlns:a16="http://schemas.microsoft.com/office/drawing/2014/main" id="{EFEAE246-877D-4FC9-997F-57ABAEEB37D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875048" y="3665116"/>
                <a:ext cx="3779848" cy="585267"/>
              </a:xfrm>
              <a:prstGeom prst="rect">
                <a:avLst/>
              </a:prstGeom>
            </p:spPr>
          </p:pic>
        </p:grp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009F20D0-BEA1-4351-8840-7453B5EB3C4E}"/>
                </a:ext>
              </a:extLst>
            </p:cNvPr>
            <p:cNvSpPr txBox="1"/>
            <p:nvPr/>
          </p:nvSpPr>
          <p:spPr>
            <a:xfrm>
              <a:off x="1019075" y="5396601"/>
              <a:ext cx="10744235" cy="646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altLang="ja-JP" sz="1200" b="1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Supplementary Figure 1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; (a) </a:t>
              </a:r>
              <a:r>
                <a:rPr lang="en-US" altLang="ja-JP" sz="1200" kern="100" dirty="0"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DPG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 and (b) </a:t>
              </a:r>
              <a:r>
                <a:rPr lang="en-US" altLang="ja-JP" sz="1200" kern="100" dirty="0"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TPG 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at 5 points (</a:t>
              </a:r>
              <a:r>
                <a:rPr lang="en-US" altLang="ja-JP" sz="1200" kern="100" dirty="0"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baseline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, 24 weeks, 1 year, 2 years and 3 years after </a:t>
              </a:r>
              <a:r>
                <a:rPr lang="en-US" altLang="ja-JP" sz="1200" kern="100" dirty="0" err="1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HTx</a:t>
              </a:r>
              <a:r>
                <a:rPr lang="en-US" altLang="ja-JP" sz="1200" kern="100" dirty="0"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)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 for high and low PVR group.</a:t>
              </a:r>
              <a:r>
                <a:rPr lang="en-US" altLang="ja-JP" sz="1200" kern="100" dirty="0"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 * p &lt; 0.01; high PVR group vs low PVR group. </a:t>
              </a:r>
            </a:p>
            <a:p>
              <a:pPr algn="just"/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DPG; diastolic pressure gradient, TPG; transpulmonary gradient, </a:t>
              </a:r>
              <a:r>
                <a:rPr lang="en-US" altLang="ja-JP" sz="1200" kern="100" dirty="0" err="1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HTx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; heart transplantation, PVR; </a:t>
              </a:r>
              <a:r>
                <a:rPr lang="en-US" altLang="ja-JP" sz="12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</a:rPr>
                <a:t>pulmonary vascular resistance.</a:t>
              </a:r>
              <a:endPara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grpSp>
          <p:nvGrpSpPr>
            <p:cNvPr id="15" name="グループ化 14">
              <a:extLst>
                <a:ext uri="{FF2B5EF4-FFF2-40B4-BE49-F238E27FC236}">
                  <a16:creationId xmlns:a16="http://schemas.microsoft.com/office/drawing/2014/main" id="{88248BCB-C48A-4165-BF95-38F2B9D8D369}"/>
                </a:ext>
              </a:extLst>
            </p:cNvPr>
            <p:cNvGrpSpPr/>
            <p:nvPr/>
          </p:nvGrpSpPr>
          <p:grpSpPr>
            <a:xfrm>
              <a:off x="6322845" y="917962"/>
              <a:ext cx="5092158" cy="4204800"/>
              <a:chOff x="6322845" y="917962"/>
              <a:chExt cx="5092158" cy="4204800"/>
            </a:xfrm>
          </p:grpSpPr>
          <p:pic>
            <p:nvPicPr>
              <p:cNvPr id="5" name="図 4">
                <a:extLst>
                  <a:ext uri="{FF2B5EF4-FFF2-40B4-BE49-F238E27FC236}">
                    <a16:creationId xmlns:a16="http://schemas.microsoft.com/office/drawing/2014/main" id="{EBDF9709-9BA8-4A8E-BA5E-2F48E922285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501439" y="917962"/>
                <a:ext cx="4913564" cy="3440291"/>
              </a:xfrm>
              <a:prstGeom prst="rect">
                <a:avLst/>
              </a:prstGeom>
            </p:spPr>
          </p:pic>
          <p:pic>
            <p:nvPicPr>
              <p:cNvPr id="7" name="図 6">
                <a:extLst>
                  <a:ext uri="{FF2B5EF4-FFF2-40B4-BE49-F238E27FC236}">
                    <a16:creationId xmlns:a16="http://schemas.microsoft.com/office/drawing/2014/main" id="{5A737F6F-D371-4D36-A837-F36A9B06B14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6322845" y="4358253"/>
                <a:ext cx="4937455" cy="764509"/>
              </a:xfrm>
              <a:prstGeom prst="rect">
                <a:avLst/>
              </a:prstGeom>
            </p:spPr>
          </p:pic>
          <p:cxnSp>
            <p:nvCxnSpPr>
              <p:cNvPr id="14" name="直線コネクタ 13">
                <a:extLst>
                  <a:ext uri="{FF2B5EF4-FFF2-40B4-BE49-F238E27FC236}">
                    <a16:creationId xmlns:a16="http://schemas.microsoft.com/office/drawing/2014/main" id="{BF32095A-FE4F-47FE-AC3C-3495A6F636EC}"/>
                  </a:ext>
                </a:extLst>
              </p:cNvPr>
              <p:cNvCxnSpPr/>
              <p:nvPr/>
            </p:nvCxnSpPr>
            <p:spPr>
              <a:xfrm>
                <a:off x="7345345" y="3607359"/>
                <a:ext cx="388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26645899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5884546D-0321-438C-B9D7-A75831377200}"/>
              </a:ext>
            </a:extLst>
          </p:cNvPr>
          <p:cNvGrpSpPr/>
          <p:nvPr/>
        </p:nvGrpSpPr>
        <p:grpSpPr>
          <a:xfrm>
            <a:off x="311888" y="221701"/>
            <a:ext cx="11568222" cy="6414598"/>
            <a:chOff x="311888" y="221701"/>
            <a:chExt cx="11568222" cy="6414598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9E49E5FF-AC4B-48FE-A83E-806C94C0C81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14849" y="221701"/>
              <a:ext cx="9762301" cy="5375879"/>
            </a:xfrm>
            <a:prstGeom prst="rect">
              <a:avLst/>
            </a:prstGeom>
          </p:spPr>
        </p:pic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90896949-7F6A-48AD-B414-D3CC789C157A}"/>
                </a:ext>
              </a:extLst>
            </p:cNvPr>
            <p:cNvSpPr txBox="1"/>
            <p:nvPr/>
          </p:nvSpPr>
          <p:spPr>
            <a:xfrm>
              <a:off x="311888" y="5805302"/>
              <a:ext cx="11568222" cy="83099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altLang="ja-JP" sz="1200" b="1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Supplementary Figure 2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; (a) RVFAC, (b) RVEDA, (c) </a:t>
              </a:r>
              <a:r>
                <a:rPr lang="en-US" altLang="ja-JP" sz="1200" kern="100" dirty="0"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RVESA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, (d) TAPSE, (e) </a:t>
              </a:r>
              <a:r>
                <a:rPr lang="en-US" altLang="ja-JP" sz="1200" kern="100" dirty="0"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RV S’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, (f) RVSP s at 4 points (1 week, 24 weeks, 1 year and 3 years after </a:t>
              </a:r>
              <a:r>
                <a:rPr lang="en-US" altLang="ja-JP" sz="1200" kern="100" dirty="0" err="1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HTx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) for high and low PVR group.</a:t>
              </a:r>
            </a:p>
            <a:p>
              <a:pPr algn="just"/>
              <a:r>
                <a:rPr lang="en-US" altLang="ja-JP" sz="1200" kern="100" dirty="0"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RVFAC; right ventricular fractional area change</a:t>
              </a:r>
              <a:r>
                <a:rPr kumimoji="1" lang="en-US" altLang="ja-JP" sz="1200" b="0" i="0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, RVEDA; </a:t>
              </a:r>
              <a:r>
                <a:rPr lang="en-US" altLang="ja-JP" sz="1200" kern="100" dirty="0"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right ventricular end diastolic area</a:t>
              </a:r>
              <a:r>
                <a:rPr kumimoji="1" lang="en-US" altLang="ja-JP" sz="1200" b="0" i="0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, RVESA; </a:t>
              </a:r>
              <a:r>
                <a:rPr lang="en-US" altLang="ja-JP" sz="1200" kern="100" dirty="0"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right ventricular end systolic area</a:t>
              </a:r>
              <a:r>
                <a:rPr kumimoji="1" lang="en-US" altLang="ja-JP" sz="1200" b="0" i="0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, TAPSE; tricuspid annular plane systolic excursion, RV; </a:t>
              </a:r>
              <a:r>
                <a:rPr lang="en-US" altLang="ja-JP" sz="1200" kern="100" dirty="0"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right ventricular</a:t>
              </a:r>
              <a:r>
                <a:rPr lang="en-US" altLang="ja-JP" sz="1200" kern="100" dirty="0">
                  <a:solidFill>
                    <a:prstClr val="black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, </a:t>
              </a:r>
              <a:r>
                <a:rPr kumimoji="1" lang="en-US" altLang="ja-JP" sz="1200" b="0" i="0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RVSP; right ventricular systolic pressure, PVR; </a:t>
              </a:r>
              <a:r>
                <a:rPr lang="en-US" altLang="ja-JP" sz="12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</a:rPr>
                <a:t>pulmonary vascular resistance</a:t>
              </a:r>
              <a:r>
                <a:rPr lang="en-US" altLang="ja-JP" sz="1200" kern="100" dirty="0">
                  <a:solidFill>
                    <a:prstClr val="black"/>
                  </a:solidFill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.</a:t>
              </a:r>
              <a:endParaRPr lang="ja-JP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788330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37CC1CAE-6A59-485E-85E6-8B8835DF4EF5}"/>
              </a:ext>
            </a:extLst>
          </p:cNvPr>
          <p:cNvGrpSpPr/>
          <p:nvPr/>
        </p:nvGrpSpPr>
        <p:grpSpPr>
          <a:xfrm>
            <a:off x="254454" y="578025"/>
            <a:ext cx="11683091" cy="5701949"/>
            <a:chOff x="254454" y="443357"/>
            <a:chExt cx="11683091" cy="5701949"/>
          </a:xfrm>
        </p:grpSpPr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id="{4ADAAD69-BC14-4B4F-A69D-3897887063C0}"/>
                </a:ext>
              </a:extLst>
            </p:cNvPr>
            <p:cNvGrpSpPr/>
            <p:nvPr/>
          </p:nvGrpSpPr>
          <p:grpSpPr>
            <a:xfrm>
              <a:off x="1521261" y="443357"/>
              <a:ext cx="8835758" cy="4033421"/>
              <a:chOff x="1376623" y="2532258"/>
              <a:chExt cx="8835758" cy="4033421"/>
            </a:xfrm>
          </p:grpSpPr>
          <p:sp>
            <p:nvSpPr>
              <p:cNvPr id="4" name="テキスト ボックス 3">
                <a:extLst>
                  <a:ext uri="{FF2B5EF4-FFF2-40B4-BE49-F238E27FC236}">
                    <a16:creationId xmlns:a16="http://schemas.microsoft.com/office/drawing/2014/main" id="{363FD752-311E-46F1-98FC-A10AA156F5F7}"/>
                  </a:ext>
                </a:extLst>
              </p:cNvPr>
              <p:cNvSpPr txBox="1"/>
              <p:nvPr/>
            </p:nvSpPr>
            <p:spPr>
              <a:xfrm>
                <a:off x="1376623" y="4435486"/>
                <a:ext cx="3062279" cy="646331"/>
              </a:xfrm>
              <a:prstGeom prst="rect">
                <a:avLst/>
              </a:prstGeom>
            </p:spPr>
            <p:style>
              <a:lnRef idx="3">
                <a:schemeClr val="lt1"/>
              </a:lnRef>
              <a:fillRef idx="1">
                <a:schemeClr val="accent1"/>
              </a:fillRef>
              <a:effectRef idx="1">
                <a:schemeClr val="accent1"/>
              </a:effectRef>
              <a:fontRef idx="minor">
                <a:schemeClr val="lt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3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VR (LVAD)</a:t>
                </a:r>
                <a:endParaRPr kumimoji="1" lang="ja-JP" altLang="en-US" sz="3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5" name="直線矢印コネクタ 4">
                <a:extLst>
                  <a:ext uri="{FF2B5EF4-FFF2-40B4-BE49-F238E27FC236}">
                    <a16:creationId xmlns:a16="http://schemas.microsoft.com/office/drawing/2014/main" id="{9523E71E-54DF-4D78-801C-ED0AD5973D07}"/>
                  </a:ext>
                </a:extLst>
              </p:cNvPr>
              <p:cNvCxnSpPr/>
              <p:nvPr/>
            </p:nvCxnSpPr>
            <p:spPr>
              <a:xfrm>
                <a:off x="4809460" y="4801604"/>
                <a:ext cx="2573079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" name="テキスト ボックス 5">
                <a:extLst>
                  <a:ext uri="{FF2B5EF4-FFF2-40B4-BE49-F238E27FC236}">
                    <a16:creationId xmlns:a16="http://schemas.microsoft.com/office/drawing/2014/main" id="{5A928318-44C0-4757-AFC1-6BE20277D3E2}"/>
                  </a:ext>
                </a:extLst>
              </p:cNvPr>
              <p:cNvSpPr txBox="1"/>
              <p:nvPr/>
            </p:nvSpPr>
            <p:spPr>
              <a:xfrm>
                <a:off x="7753100" y="4435485"/>
                <a:ext cx="2459281" cy="646331"/>
              </a:xfrm>
              <a:prstGeom prst="rect">
                <a:avLst/>
              </a:prstGeom>
            </p:spPr>
            <p:style>
              <a:lnRef idx="1">
                <a:schemeClr val="accent4"/>
              </a:lnRef>
              <a:fillRef idx="2">
                <a:schemeClr val="accent4"/>
              </a:fillRef>
              <a:effectRef idx="1">
                <a:schemeClr val="accent4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3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CWP(3y)</a:t>
                </a:r>
                <a:endParaRPr kumimoji="1" lang="ja-JP" altLang="en-US" sz="3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テキスト ボックス 6">
                <a:extLst>
                  <a:ext uri="{FF2B5EF4-FFF2-40B4-BE49-F238E27FC236}">
                    <a16:creationId xmlns:a16="http://schemas.microsoft.com/office/drawing/2014/main" id="{F66E1D5B-BB97-4F9F-9524-D50B252AC0D8}"/>
                  </a:ext>
                </a:extLst>
              </p:cNvPr>
              <p:cNvSpPr txBox="1"/>
              <p:nvPr/>
            </p:nvSpPr>
            <p:spPr>
              <a:xfrm>
                <a:off x="5098120" y="2532258"/>
                <a:ext cx="1967024" cy="646331"/>
              </a:xfrm>
              <a:prstGeom prst="rect">
                <a:avLst/>
              </a:prstGeom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3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AP(3y)</a:t>
                </a:r>
                <a:endParaRPr kumimoji="1" lang="ja-JP" altLang="en-US" sz="3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8" name="直線矢印コネクタ 7">
                <a:extLst>
                  <a:ext uri="{FF2B5EF4-FFF2-40B4-BE49-F238E27FC236}">
                    <a16:creationId xmlns:a16="http://schemas.microsoft.com/office/drawing/2014/main" id="{33680FB5-9708-4A37-822D-C5F9423FCB8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496149" y="3178589"/>
                <a:ext cx="1399953" cy="973363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直線矢印コネクタ 8">
                <a:extLst>
                  <a:ext uri="{FF2B5EF4-FFF2-40B4-BE49-F238E27FC236}">
                    <a16:creationId xmlns:a16="http://schemas.microsoft.com/office/drawing/2014/main" id="{48B97512-A33D-4259-915E-C1AA58FBB88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95900" y="3187901"/>
                <a:ext cx="1304260" cy="87187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テキスト ボックス 9">
                <a:extLst>
                  <a:ext uri="{FF2B5EF4-FFF2-40B4-BE49-F238E27FC236}">
                    <a16:creationId xmlns:a16="http://schemas.microsoft.com/office/drawing/2014/main" id="{782457AB-7D21-480E-A38C-68E1A206E2B9}"/>
                  </a:ext>
                </a:extLst>
              </p:cNvPr>
              <p:cNvSpPr txBox="1"/>
              <p:nvPr/>
            </p:nvSpPr>
            <p:spPr>
              <a:xfrm>
                <a:off x="2452395" y="2792839"/>
                <a:ext cx="1734879" cy="830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2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 = 1.22</a:t>
                </a:r>
              </a:p>
              <a:p>
                <a:r>
                  <a:rPr lang="en-US" altLang="ja-JP" sz="2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 </a:t>
                </a:r>
                <a:r>
                  <a:rPr kumimoji="1" lang="en-US" altLang="ja-JP" sz="2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= 0.0021</a:t>
                </a:r>
              </a:p>
            </p:txBody>
          </p:sp>
          <p:sp>
            <p:nvSpPr>
              <p:cNvPr id="11" name="テキスト ボックス 10">
                <a:extLst>
                  <a:ext uri="{FF2B5EF4-FFF2-40B4-BE49-F238E27FC236}">
                    <a16:creationId xmlns:a16="http://schemas.microsoft.com/office/drawing/2014/main" id="{C507893B-AFCF-4314-84B2-DB030139E1AD}"/>
                  </a:ext>
                </a:extLst>
              </p:cNvPr>
              <p:cNvSpPr txBox="1"/>
              <p:nvPr/>
            </p:nvSpPr>
            <p:spPr>
              <a:xfrm>
                <a:off x="8278895" y="2792839"/>
                <a:ext cx="1800444" cy="830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2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 = 1.19</a:t>
                </a:r>
              </a:p>
              <a:p>
                <a:r>
                  <a:rPr lang="en-US" altLang="ja-JP" sz="2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 &lt; </a:t>
                </a:r>
                <a:r>
                  <a:rPr kumimoji="1" lang="en-US" altLang="ja-JP" sz="2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001</a:t>
                </a:r>
              </a:p>
            </p:txBody>
          </p:sp>
          <p:sp>
            <p:nvSpPr>
              <p:cNvPr id="12" name="テキスト ボックス 11">
                <a:extLst>
                  <a:ext uri="{FF2B5EF4-FFF2-40B4-BE49-F238E27FC236}">
                    <a16:creationId xmlns:a16="http://schemas.microsoft.com/office/drawing/2014/main" id="{9193F761-AFE0-4EFD-BFCD-E880B6F912E9}"/>
                  </a:ext>
                </a:extLst>
              </p:cNvPr>
              <p:cNvSpPr txBox="1"/>
              <p:nvPr/>
            </p:nvSpPr>
            <p:spPr>
              <a:xfrm>
                <a:off x="4196125" y="5365350"/>
                <a:ext cx="3932275" cy="12003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2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irect, b = 0.035, P = 0.93</a:t>
                </a:r>
              </a:p>
              <a:p>
                <a:r>
                  <a:rPr kumimoji="1" lang="en-US" altLang="ja-JP" sz="2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direct, b = 1.458</a:t>
                </a:r>
              </a:p>
              <a:p>
                <a:r>
                  <a:rPr lang="en-US" altLang="ja-JP" sz="2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otal, b = 1.494, P = 0.012</a:t>
                </a:r>
                <a:endParaRPr kumimoji="1" lang="ja-JP" altLang="en-US" sz="2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0BA84B44-DDD5-423E-86E0-003DE4364AE0}"/>
                </a:ext>
              </a:extLst>
            </p:cNvPr>
            <p:cNvSpPr txBox="1"/>
            <p:nvPr/>
          </p:nvSpPr>
          <p:spPr>
            <a:xfrm>
              <a:off x="254454" y="4760311"/>
              <a:ext cx="11683091" cy="1384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3; </a:t>
              </a:r>
              <a:endParaRPr lang="en-US" altLang="ja-JP" sz="12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pPr algn="just"/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In order to analyze the relationship between PVR measured during LVAD support and PCWP 3 years after heart </a:t>
              </a:r>
              <a:r>
                <a:rPr lang="en-US" altLang="ja-JP" sz="1200" kern="100" dirty="0" err="1">
                  <a:effectLst/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HTx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, we constructed the mediation models for analysis.</a:t>
              </a:r>
              <a:endPara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pPr algn="just"/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To determine the relative contribution of RAP 3 years after </a:t>
              </a:r>
              <a:r>
                <a:rPr lang="en-US" altLang="ja-JP" sz="1200" kern="100" dirty="0" err="1">
                  <a:effectLst/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HTx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 on PCWP 3 years after </a:t>
              </a:r>
              <a:r>
                <a:rPr lang="en-US" altLang="ja-JP" sz="1200" kern="100" dirty="0" err="1">
                  <a:effectLst/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HTx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, mediation analysis was conducted through Hayes mediation model along with PROCESS plugin provided by Andrew Hayes (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  <a:hlinkClick r:id="rId2"/>
                </a:rPr>
                <a:t>http://www.processmacro.org/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).</a:t>
              </a:r>
            </a:p>
            <a:p>
              <a:pPr algn="just"/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The result showed that PVR measured during LVAD support did not have a direct effect on PCWP 3 years after </a:t>
              </a:r>
              <a:r>
                <a:rPr lang="en-US" altLang="ja-JP" sz="1200" kern="100" dirty="0" err="1">
                  <a:effectLst/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HTx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 but that its effect was rather mediated through RAP.</a:t>
              </a:r>
            </a:p>
            <a:p>
              <a:pPr algn="just"/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PVR; </a:t>
              </a:r>
              <a:r>
                <a:rPr lang="en-US" altLang="ja-JP" sz="12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</a:rPr>
                <a:t>pulmonary vascular resistance, </a:t>
              </a:r>
              <a:r>
                <a:rPr lang="en-US" altLang="ja-JP" sz="1200" kern="100" dirty="0" err="1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HTx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; LVAD; l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eft ventricular </a:t>
              </a:r>
              <a:r>
                <a:rPr lang="en-US" altLang="ja-JP" sz="1200" kern="100" dirty="0">
                  <a:latin typeface="Times New Roman" panose="02020603050405020304" pitchFamily="18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ssist device 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, PCWP; </a:t>
              </a:r>
              <a:r>
                <a:rPr lang="en-US" altLang="ja-JP" sz="120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  <a:sym typeface="Wingdings" panose="05000000000000000000" pitchFamily="2" charset="2"/>
                </a:rPr>
                <a:t>pulmonary capillary wedge pressure, </a:t>
              </a:r>
              <a:r>
                <a:rPr lang="en-US" altLang="ja-JP" sz="1200" dirty="0" err="1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  <a:sym typeface="Wingdings" panose="05000000000000000000" pitchFamily="2" charset="2"/>
                </a:rPr>
                <a:t>HTx</a:t>
              </a:r>
              <a:r>
                <a:rPr lang="en-US" altLang="ja-JP" sz="120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  <a:sym typeface="Wingdings" panose="05000000000000000000" pitchFamily="2" charset="2"/>
                </a:rPr>
                <a:t>; 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heart transplantation, </a:t>
              </a:r>
              <a:r>
                <a:rPr lang="en-US" altLang="ja-JP" sz="1200" kern="100" dirty="0" err="1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mPAP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; mean pulmonary artery pressure, RAP; right arterial pressure</a:t>
              </a:r>
              <a:r>
                <a:rPr lang="en-US" altLang="ja-JP" sz="120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  <a:sym typeface="Wingdings" panose="05000000000000000000" pitchFamily="2" charset="2"/>
                </a:rPr>
                <a:t>, CI; cardiac index.</a:t>
              </a:r>
              <a:endParaRPr lang="ja-JP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487701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16162561-7760-4226-BD20-8ED75C51DDC7}"/>
              </a:ext>
            </a:extLst>
          </p:cNvPr>
          <p:cNvGrpSpPr/>
          <p:nvPr/>
        </p:nvGrpSpPr>
        <p:grpSpPr>
          <a:xfrm>
            <a:off x="631695" y="212802"/>
            <a:ext cx="10928609" cy="6432396"/>
            <a:chOff x="631695" y="212802"/>
            <a:chExt cx="10928609" cy="6432396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28727FE5-BA66-424C-8042-5C88EDD45C5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2063" y="212802"/>
              <a:ext cx="10176656" cy="5364000"/>
            </a:xfrm>
            <a:prstGeom prst="rect">
              <a:avLst/>
            </a:prstGeom>
          </p:spPr>
        </p:pic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B19DD461-CE71-47F2-9210-201F0F48F7DA}"/>
                </a:ext>
              </a:extLst>
            </p:cNvPr>
            <p:cNvSpPr txBox="1"/>
            <p:nvPr/>
          </p:nvSpPr>
          <p:spPr>
            <a:xfrm>
              <a:off x="631695" y="5814201"/>
              <a:ext cx="10928609" cy="83099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4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; (a) PVR at 5 points (baseline, 24 weeks, 1 year, 2 years and 3 years after </a:t>
              </a:r>
              <a:r>
                <a:rPr lang="en-US" altLang="ja-JP" sz="1200" kern="100" dirty="0" err="1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HTx</a:t>
              </a:r>
              <a:r>
                <a:rPr lang="en-US" altLang="ja-JP" sz="1200" kern="100" dirty="0"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)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 (b) </a:t>
              </a:r>
              <a:r>
                <a:rPr lang="en-US" altLang="ja-JP" sz="1200" kern="100" dirty="0" err="1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mPAP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, (c) </a:t>
              </a:r>
              <a:r>
                <a:rPr lang="en-US" altLang="ja-JP" sz="1200" kern="100" dirty="0" err="1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mRAP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, (d) </a:t>
              </a:r>
              <a:r>
                <a:rPr lang="en-US" altLang="ja-JP" sz="1200" kern="100" dirty="0" err="1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mPCWP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, (e) CI and (f) </a:t>
              </a:r>
              <a:r>
                <a:rPr lang="en-US" altLang="ja-JP" sz="1200" kern="100" dirty="0" err="1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PAPi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 at 5 points (4 weeks, 24 weeks, 1 year, 2 years and 3 years after </a:t>
              </a:r>
              <a:r>
                <a:rPr lang="en-US" altLang="ja-JP" sz="1200" kern="100" dirty="0" err="1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HTx</a:t>
              </a:r>
              <a:r>
                <a:rPr lang="en-US" altLang="ja-JP" sz="1200" kern="100" dirty="0"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)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 for post </a:t>
              </a:r>
              <a:r>
                <a:rPr lang="en-US" altLang="ja-JP" sz="1200" kern="100" dirty="0" err="1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HTx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 3 years CAV and </a:t>
              </a:r>
              <a:r>
                <a:rPr lang="en-US" altLang="ja-JP" sz="1200" kern="100" dirty="0"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post </a:t>
              </a:r>
              <a:r>
                <a:rPr lang="en-US" altLang="ja-JP" sz="1200" kern="100" dirty="0" err="1"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HTx</a:t>
              </a:r>
              <a:r>
                <a:rPr lang="en-US" altLang="ja-JP" sz="1200" kern="100" dirty="0"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 3 years non CAV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 group.</a:t>
              </a:r>
              <a:r>
                <a:rPr lang="en-US" altLang="ja-JP" sz="1200" kern="100" dirty="0"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 </a:t>
              </a:r>
            </a:p>
            <a:p>
              <a:pPr algn="just"/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PVR; </a:t>
              </a:r>
              <a:r>
                <a:rPr lang="en-US" altLang="ja-JP" sz="12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</a:rPr>
                <a:t>pulmonary vascular resistance, </a:t>
              </a:r>
              <a:r>
                <a:rPr lang="en-US" altLang="ja-JP" sz="1200" kern="100" dirty="0" err="1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HTx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; heart transplantation, </a:t>
              </a:r>
              <a:r>
                <a:rPr lang="en-US" altLang="ja-JP" sz="1200" kern="100" dirty="0" err="1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mPAP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; mean pulmonary artery pressure, </a:t>
              </a:r>
              <a:r>
                <a:rPr lang="en-US" altLang="ja-JP" sz="1200" kern="100" dirty="0" err="1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mRAP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; mean right arterial pressure, </a:t>
              </a:r>
              <a:r>
                <a:rPr lang="en-US" altLang="ja-JP" sz="1200" kern="100" dirty="0" err="1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mPCWP</a:t>
              </a:r>
              <a:r>
                <a:rPr lang="en-US" altLang="ja-JP" sz="1200" kern="100" dirty="0">
                  <a:effectLst/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; </a:t>
              </a:r>
              <a:r>
                <a:rPr lang="en-US" altLang="ja-JP" sz="120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  <a:sym typeface="Wingdings" panose="05000000000000000000" pitchFamily="2" charset="2"/>
                </a:rPr>
                <a:t>mean pulmonary capillary wedge pressure, CI; cardiac index, </a:t>
              </a:r>
              <a:r>
                <a:rPr lang="en-US" altLang="ja-JP" sz="1200" dirty="0" err="1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  <a:sym typeface="Wingdings" panose="05000000000000000000" pitchFamily="2" charset="2"/>
                </a:rPr>
                <a:t>PAPi</a:t>
              </a:r>
              <a:r>
                <a:rPr lang="en-US" altLang="ja-JP" sz="120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  <a:sym typeface="Wingdings" panose="05000000000000000000" pitchFamily="2" charset="2"/>
                </a:rPr>
                <a:t>; pulmonary artery </a:t>
              </a:r>
              <a:r>
                <a:rPr lang="en-US" altLang="ja-JP" sz="1200" dirty="0" err="1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  <a:sym typeface="Wingdings" panose="05000000000000000000" pitchFamily="2" charset="2"/>
                </a:rPr>
                <a:t>pulsatility</a:t>
              </a:r>
              <a:r>
                <a:rPr lang="en-US" altLang="ja-JP" sz="1200" dirty="0"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  <a:sym typeface="Wingdings" panose="05000000000000000000" pitchFamily="2" charset="2"/>
                </a:rPr>
                <a:t> index, CAV; cardiac allograft vasculopathy.</a:t>
              </a:r>
              <a:endParaRPr kumimoji="1" lang="ja-JP" altLang="en-US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816531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522</Words>
  <Application>Microsoft Office PowerPoint</Application>
  <PresentationFormat>ワイド画面</PresentationFormat>
  <Paragraphs>21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角田 昇隆</dc:creator>
  <cp:lastModifiedBy>角田 昇隆</cp:lastModifiedBy>
  <cp:revision>7</cp:revision>
  <dcterms:created xsi:type="dcterms:W3CDTF">2021-11-14T08:46:02Z</dcterms:created>
  <dcterms:modified xsi:type="dcterms:W3CDTF">2022-02-13T15:35:55Z</dcterms:modified>
</cp:coreProperties>
</file>